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88571"/>
  </p:normalViewPr>
  <p:slideViewPr>
    <p:cSldViewPr snapToGrid="0">
      <p:cViewPr varScale="1">
        <p:scale>
          <a:sx n="113" d="100"/>
          <a:sy n="113" d="100"/>
        </p:scale>
        <p:origin x="106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97837B32-6E84-318E-815E-435E63EC3D98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4D1C586-BBB5-0419-25C9-77E32CD81F78}"/>
              </a:ext>
            </a:extLst>
          </p:cNvPr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fld id="{668B3984-FBAC-E842-91B9-49EBC97BEE19}" type="datetimeFigureOut">
              <a:rPr lang="en-US"/>
              <a:pPr>
                <a:defRPr/>
              </a:pPr>
              <a:t>8/14/23</a:t>
            </a:fld>
            <a:endParaRPr lang="en-US"/>
          </a:p>
        </p:txBody>
      </p:sp>
      <p:sp>
        <p:nvSpPr>
          <p:cNvPr id="4" name="Slide Image Placeholder 3">
            <a:extLst>
              <a:ext uri="{FF2B5EF4-FFF2-40B4-BE49-F238E27FC236}">
                <a16:creationId xmlns:a16="http://schemas.microsoft.com/office/drawing/2014/main" id="{BDA3AC6B-A521-EE80-A26A-FEBE5681798C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>
            <a:extLst>
              <a:ext uri="{FF2B5EF4-FFF2-40B4-BE49-F238E27FC236}">
                <a16:creationId xmlns:a16="http://schemas.microsoft.com/office/drawing/2014/main" id="{E4BF832D-42D2-CD96-7EE3-178FD7ABF20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73C49D9-DCF3-AC27-D743-A1215E41B544}"/>
              </a:ext>
            </a:extLst>
          </p:cNvPr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69D6CCA-B0AB-A7B8-07FC-EFBA0CE0B351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fld id="{A4E96987-FFF1-2844-A7C3-B3ADF237224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dirty="0"/>
              <a:t>Supplementary Figure 1. </a:t>
            </a:r>
            <a:r>
              <a:rPr lang="en-US" sz="1200" dirty="0"/>
              <a:t>(left) </a:t>
            </a:r>
            <a:r>
              <a:rPr lang="en-US" sz="1200" dirty="0">
                <a:effectLst/>
              </a:rPr>
              <a:t>Flowchart describing the number of ECHO cohorts and participants that met the inclusion criteria for our </a:t>
            </a:r>
            <a:r>
              <a:rPr lang="en-US" sz="1200" dirty="0"/>
              <a:t>CpG</a:t>
            </a:r>
            <a:r>
              <a:rPr lang="en-US" sz="1200" dirty="0">
                <a:effectLst/>
              </a:rPr>
              <a:t>-specific analysis. (right) Flowchart describing the number of ECHO cohorts and participants that met the inclusion criteria for our epigenetic clock analysis.</a:t>
            </a: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B42AE70-573D-2549-9EE1-26B8FEA1E3A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930267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F790B0-DA88-48BE-33AB-8131C12C8E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3F15AB-2826-554C-8150-72BACD591590}" type="datetimeFigureOut">
              <a:rPr lang="en-US"/>
              <a:pPr>
                <a:defRPr/>
              </a:pPr>
              <a:t>8/1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0EFD12-9285-C90A-1EC2-6A491C20BA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782396-86AE-E5F5-1944-7B5439973E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9A2EDD9-83CD-A84B-B403-CA1DA0078C2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92705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C3E12D-E3B7-0D7D-A07C-3DDD820B8C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B516173-DCF0-C6EF-06EA-06A74C3C7E3C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537D03-49D5-F94E-26E8-A4454665BE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02249E65-D22D-3148-9E41-28E2C5F71DE7}" type="datetimeFigureOut">
              <a:rPr lang="en-US" smtClean="0"/>
              <a:pPr>
                <a:defRPr/>
              </a:pPr>
              <a:t>8/1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955E3EF-7C34-A1EB-A93B-CEF64F94A5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1DC40C-B920-D9F0-9E79-316DCA64DE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EEAF9F38-20E6-204D-8898-3133D8A9DB6E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B8D33D-718D-1390-6934-C498561813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FDE2763-F8AD-7CFB-AE21-0B5809382584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2C4C0D-1BAC-481E-1D08-8DB46D32ED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02249E65-D22D-3148-9E41-28E2C5F71DE7}" type="datetimeFigureOut">
              <a:rPr lang="en-US" smtClean="0"/>
              <a:pPr>
                <a:defRPr/>
              </a:pPr>
              <a:t>8/1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302196-8DBF-D168-1B8D-004C011610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DB940C-C476-96DF-7EE6-F681B7CBB2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EEAF9F38-20E6-204D-8898-3133D8A9DB6E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E8AF9C-0DA1-3F75-5FD0-DF4873E44B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67D5FC0-4EED-7B4F-AC43-DBB342C2736E}" type="datetimeFigureOut">
              <a:rPr lang="en-US"/>
              <a:pPr>
                <a:defRPr/>
              </a:pPr>
              <a:t>8/1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4E4C00-41B1-3514-88D6-3C18476AF8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EADA30-910F-D9F3-6FF9-D5B49CCFE2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470EC64-DAFD-5B43-95EA-965555A5FB0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93115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12A51A-7BDE-32AC-A8E2-47D87B4AD5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9165631-0920-5849-B5DF-E1F7473D7B12}" type="datetimeFigureOut">
              <a:rPr lang="en-US"/>
              <a:pPr>
                <a:defRPr/>
              </a:pPr>
              <a:t>8/1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CA99B0-89CC-5F64-B20F-7897D7696C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CD4A30-BBA1-B346-A8D9-DA06A851CD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F5588E6-6AF7-2D4A-A76D-27F2532AF7C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69327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AD366EF6-0FF6-AE86-384F-D349FB316F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BBCE375-E0A9-5943-99AC-DD2198E18A58}" type="datetimeFigureOut">
              <a:rPr lang="en-US"/>
              <a:pPr>
                <a:defRPr/>
              </a:pPr>
              <a:t>8/14/23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030B2466-B63E-FA97-63C1-6E587ACF93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F459B73D-3137-6371-87C6-2E90D885DE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3B6073C-F79A-FE48-B973-956871D6937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01599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>
            <a:extLst>
              <a:ext uri="{FF2B5EF4-FFF2-40B4-BE49-F238E27FC236}">
                <a16:creationId xmlns:a16="http://schemas.microsoft.com/office/drawing/2014/main" id="{D300EB30-1780-10C9-CBF1-FCB32F1ECD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412DA1D-10D6-3E40-8A1A-32B5F7702E37}" type="datetimeFigureOut">
              <a:rPr lang="en-US"/>
              <a:pPr>
                <a:defRPr/>
              </a:pPr>
              <a:t>8/14/23</a:t>
            </a:fld>
            <a:endParaRPr lang="en-US"/>
          </a:p>
        </p:txBody>
      </p:sp>
      <p:sp>
        <p:nvSpPr>
          <p:cNvPr id="8" name="Footer Placeholder 4">
            <a:extLst>
              <a:ext uri="{FF2B5EF4-FFF2-40B4-BE49-F238E27FC236}">
                <a16:creationId xmlns:a16="http://schemas.microsoft.com/office/drawing/2014/main" id="{8F876D4D-0BD4-4D1D-0241-E123CB3D55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6033B154-C50F-67C6-7F5E-A32A172953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6238D4E-92E7-044A-99AB-1694902D3F7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28686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>
            <a:extLst>
              <a:ext uri="{FF2B5EF4-FFF2-40B4-BE49-F238E27FC236}">
                <a16:creationId xmlns:a16="http://schemas.microsoft.com/office/drawing/2014/main" id="{D7C50AB7-3C73-2DCA-3A82-C4194DBE72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75967E2-3203-3448-AA6C-F8F425D4E192}" type="datetimeFigureOut">
              <a:rPr lang="en-US"/>
              <a:pPr>
                <a:defRPr/>
              </a:pPr>
              <a:t>8/14/23</a:t>
            </a:fld>
            <a:endParaRPr lang="en-US"/>
          </a:p>
        </p:txBody>
      </p:sp>
      <p:sp>
        <p:nvSpPr>
          <p:cNvPr id="4" name="Footer Placeholder 4">
            <a:extLst>
              <a:ext uri="{FF2B5EF4-FFF2-40B4-BE49-F238E27FC236}">
                <a16:creationId xmlns:a16="http://schemas.microsoft.com/office/drawing/2014/main" id="{E51BC5C3-1441-78C3-CCAA-8F4853FCDA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>
            <a:extLst>
              <a:ext uri="{FF2B5EF4-FFF2-40B4-BE49-F238E27FC236}">
                <a16:creationId xmlns:a16="http://schemas.microsoft.com/office/drawing/2014/main" id="{8B1FE363-149D-5521-4D65-145E235052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5B3F117-3B7A-F249-B3DF-1A4739267B6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45728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>
              <a:ext uri="{FF2B5EF4-FFF2-40B4-BE49-F238E27FC236}">
                <a16:creationId xmlns:a16="http://schemas.microsoft.com/office/drawing/2014/main" id="{C03F066D-CF3E-8C42-3592-985EE67A29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C9CB0B2-81B5-1C40-ACC9-064FF508007C}" type="datetimeFigureOut">
              <a:rPr lang="en-US"/>
              <a:pPr>
                <a:defRPr/>
              </a:pPr>
              <a:t>8/14/23</a:t>
            </a:fld>
            <a:endParaRPr lang="en-US"/>
          </a:p>
        </p:txBody>
      </p:sp>
      <p:sp>
        <p:nvSpPr>
          <p:cNvPr id="3" name="Footer Placeholder 4">
            <a:extLst>
              <a:ext uri="{FF2B5EF4-FFF2-40B4-BE49-F238E27FC236}">
                <a16:creationId xmlns:a16="http://schemas.microsoft.com/office/drawing/2014/main" id="{C866386E-58E2-0CC0-7171-4BD8EC6501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B13C9132-8E9E-07BD-EE6D-B1AC1B93F1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1ACD250-CFA6-9E4C-8974-6C16B81BE09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78428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AE74943D-6EAB-3510-C6EB-8FBB7669A8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572D4DB-A870-2E4E-B4F1-B33E9F12DF0F}" type="datetimeFigureOut">
              <a:rPr lang="en-US"/>
              <a:pPr>
                <a:defRPr/>
              </a:pPr>
              <a:t>8/14/23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27CEBE4F-3653-BBEF-90C4-81B13BA487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FD69090B-5FD4-0132-5C8C-DC47147080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514D89F-FD2D-EA4F-94A9-6C564EF457C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92357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0CD377-C2F1-0964-713D-BDB7F49EA2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CB13D12-83DF-5689-F459-29DA905A3031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DAF95E-718D-8DFA-E98F-FC38D44F6D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02249E65-D22D-3148-9E41-28E2C5F71DE7}" type="datetimeFigureOut">
              <a:rPr lang="en-US" smtClean="0"/>
              <a:pPr>
                <a:defRPr/>
              </a:pPr>
              <a:t>8/1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CC4B37-C1FC-EAAE-9F29-CC62D8C765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9ED22E-F3CB-64BE-8603-C8A3A40A87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EEAF9F38-20E6-204D-8898-3133D8A9DB6E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>
            <a:extLst>
              <a:ext uri="{FF2B5EF4-FFF2-40B4-BE49-F238E27FC236}">
                <a16:creationId xmlns:a16="http://schemas.microsoft.com/office/drawing/2014/main" id="{2967E15F-25DA-EE21-14F0-3A6B1CF2A990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 bwMode="auto"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7" name="Text Placeholder 2">
            <a:extLst>
              <a:ext uri="{FF2B5EF4-FFF2-40B4-BE49-F238E27FC236}">
                <a16:creationId xmlns:a16="http://schemas.microsoft.com/office/drawing/2014/main" id="{50172A88-13D9-AA9B-8696-4C1FFE119547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5E396A3-F296-ACDD-CB80-AFFA53536D4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02249E65-D22D-3148-9E41-28E2C5F71DE7}" type="datetimeFigureOut">
              <a:rPr lang="en-US"/>
              <a:pPr>
                <a:defRPr/>
              </a:pPr>
              <a:t>8/1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C2D844-7C29-DC2C-5BFE-7367FCB637C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BD0AE7-E244-6F8C-952B-EAD8F0027F2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EEAF9F38-20E6-204D-8898-3133D8A9DB6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2pPr>
      <a:lvl3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3pPr>
      <a:lvl4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4pPr>
      <a:lvl5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5pPr>
      <a:lvl6pPr marL="4572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6pPr>
      <a:lvl7pPr marL="9144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7pPr>
      <a:lvl8pPr marL="13716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8pPr>
      <a:lvl9pPr marL="18288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9pPr>
    </p:titleStyle>
    <p:bodyStyle>
      <a:lvl1pPr marL="228600" indent="-228600" algn="l" rtl="0" eaLnBrk="0" fontAlgn="base" hangingPunct="0">
        <a:lnSpc>
          <a:spcPct val="90000"/>
        </a:lnSpc>
        <a:spcBef>
          <a:spcPts val="1000"/>
        </a:spcBef>
        <a:spcAft>
          <a:spcPct val="0"/>
        </a:spcAft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A0A16C15-AFA4-2564-A85E-EDC504555BFE}"/>
              </a:ext>
            </a:extLst>
          </p:cNvPr>
          <p:cNvSpPr/>
          <p:nvPr/>
        </p:nvSpPr>
        <p:spPr>
          <a:xfrm>
            <a:off x="480162" y="640954"/>
            <a:ext cx="1713187" cy="557049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/>
              <a:t>9035 participants with high quality Illumina DNA methylation data</a:t>
            </a:r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718C07C9-C9C0-A181-CA09-7E5C0956FC2C}"/>
              </a:ext>
            </a:extLst>
          </p:cNvPr>
          <p:cNvCxnSpPr>
            <a:cxnSpLocks/>
          </p:cNvCxnSpPr>
          <p:nvPr/>
        </p:nvCxnSpPr>
        <p:spPr>
          <a:xfrm>
            <a:off x="1546960" y="1453430"/>
            <a:ext cx="184456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Rectangle 8">
            <a:extLst>
              <a:ext uri="{FF2B5EF4-FFF2-40B4-BE49-F238E27FC236}">
                <a16:creationId xmlns:a16="http://schemas.microsoft.com/office/drawing/2014/main" id="{3089900E-A8DB-0EDC-20EC-BEED9A4A5629}"/>
              </a:ext>
            </a:extLst>
          </p:cNvPr>
          <p:cNvSpPr/>
          <p:nvPr/>
        </p:nvSpPr>
        <p:spPr>
          <a:xfrm>
            <a:off x="480161" y="1741914"/>
            <a:ext cx="1713187" cy="557049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/>
              <a:t>8028 child samples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0C6B0A97-929C-F661-2A27-9135F7E75360}"/>
              </a:ext>
            </a:extLst>
          </p:cNvPr>
          <p:cNvSpPr/>
          <p:nvPr/>
        </p:nvSpPr>
        <p:spPr>
          <a:xfrm>
            <a:off x="3601732" y="1171727"/>
            <a:ext cx="1965960" cy="557049"/>
          </a:xfrm>
          <a:prstGeom prst="rect">
            <a:avLst/>
          </a:prstGeom>
          <a:solidFill>
            <a:schemeClr val="bg2"/>
          </a:solidFill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/>
              <a:t>Remove 1007 maternal samples</a:t>
            </a:r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B6E132A8-0674-F424-717A-2E3069824DD1}"/>
              </a:ext>
            </a:extLst>
          </p:cNvPr>
          <p:cNvCxnSpPr>
            <a:cxnSpLocks/>
          </p:cNvCxnSpPr>
          <p:nvPr/>
        </p:nvCxnSpPr>
        <p:spPr>
          <a:xfrm>
            <a:off x="1546960" y="2567279"/>
            <a:ext cx="184456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Rectangle 12">
            <a:extLst>
              <a:ext uri="{FF2B5EF4-FFF2-40B4-BE49-F238E27FC236}">
                <a16:creationId xmlns:a16="http://schemas.microsoft.com/office/drawing/2014/main" id="{08AEE7DE-91F2-AFB0-EAB1-32CCE9ED2B9B}"/>
              </a:ext>
            </a:extLst>
          </p:cNvPr>
          <p:cNvSpPr/>
          <p:nvPr/>
        </p:nvSpPr>
        <p:spPr>
          <a:xfrm>
            <a:off x="3601732" y="2291074"/>
            <a:ext cx="1965953" cy="557049"/>
          </a:xfrm>
          <a:prstGeom prst="rect">
            <a:avLst/>
          </a:prstGeom>
          <a:solidFill>
            <a:schemeClr val="bg2"/>
          </a:solidFill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/>
              <a:t>Remove 5592 samples from tissues </a:t>
            </a:r>
            <a:r>
              <a:rPr lang="en-US" sz="1200" i="1" dirty="0"/>
              <a:t>other than </a:t>
            </a:r>
            <a:r>
              <a:rPr lang="en-US" sz="1200" dirty="0"/>
              <a:t>cord blood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4EB46E5C-7CBC-3A46-23BB-3B696CF636BF}"/>
              </a:ext>
            </a:extLst>
          </p:cNvPr>
          <p:cNvSpPr/>
          <p:nvPr/>
        </p:nvSpPr>
        <p:spPr>
          <a:xfrm>
            <a:off x="480161" y="2842874"/>
            <a:ext cx="1713187" cy="557049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/>
              <a:t>2436 cord blood child samples</a:t>
            </a:r>
          </a:p>
        </p:txBody>
      </p: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D4FDC5B1-9B6C-D625-B466-FAECF28636EF}"/>
              </a:ext>
            </a:extLst>
          </p:cNvPr>
          <p:cNvCxnSpPr>
            <a:cxnSpLocks/>
          </p:cNvCxnSpPr>
          <p:nvPr/>
        </p:nvCxnSpPr>
        <p:spPr>
          <a:xfrm>
            <a:off x="1546960" y="3688945"/>
            <a:ext cx="184456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Rectangle 16">
            <a:extLst>
              <a:ext uri="{FF2B5EF4-FFF2-40B4-BE49-F238E27FC236}">
                <a16:creationId xmlns:a16="http://schemas.microsoft.com/office/drawing/2014/main" id="{A8DCE9E4-707B-5331-AB56-F67F4F998CC6}"/>
              </a:ext>
            </a:extLst>
          </p:cNvPr>
          <p:cNvSpPr/>
          <p:nvPr/>
        </p:nvSpPr>
        <p:spPr>
          <a:xfrm>
            <a:off x="3601732" y="3410421"/>
            <a:ext cx="1965948" cy="557049"/>
          </a:xfrm>
          <a:prstGeom prst="rect">
            <a:avLst/>
          </a:prstGeom>
          <a:solidFill>
            <a:schemeClr val="bg2"/>
          </a:solidFill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/>
              <a:t>Remove 1088 samples from EPIC and 27K Illumina platforms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F947162A-AF91-DD22-97E4-7666F2DBAA9B}"/>
              </a:ext>
            </a:extLst>
          </p:cNvPr>
          <p:cNvSpPr/>
          <p:nvPr/>
        </p:nvSpPr>
        <p:spPr>
          <a:xfrm>
            <a:off x="480161" y="3943834"/>
            <a:ext cx="1713187" cy="557049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/>
              <a:t>1348 cord blood 450K child samples</a:t>
            </a:r>
          </a:p>
        </p:txBody>
      </p: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59DAEF53-9B87-6C4A-8292-4F0C66C07CFE}"/>
              </a:ext>
            </a:extLst>
          </p:cNvPr>
          <p:cNvCxnSpPr>
            <a:cxnSpLocks/>
          </p:cNvCxnSpPr>
          <p:nvPr/>
        </p:nvCxnSpPr>
        <p:spPr>
          <a:xfrm>
            <a:off x="1546960" y="4782132"/>
            <a:ext cx="184456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Rectangle 20">
            <a:extLst>
              <a:ext uri="{FF2B5EF4-FFF2-40B4-BE49-F238E27FC236}">
                <a16:creationId xmlns:a16="http://schemas.microsoft.com/office/drawing/2014/main" id="{7ED4B9A4-840A-0DF8-8A02-E9A2A6765F1F}"/>
              </a:ext>
            </a:extLst>
          </p:cNvPr>
          <p:cNvSpPr/>
          <p:nvPr/>
        </p:nvSpPr>
        <p:spPr>
          <a:xfrm>
            <a:off x="3601732" y="4529768"/>
            <a:ext cx="1965945" cy="557049"/>
          </a:xfrm>
          <a:prstGeom prst="rect">
            <a:avLst/>
          </a:prstGeom>
          <a:solidFill>
            <a:schemeClr val="bg2"/>
          </a:solidFill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/>
              <a:t>Remove 152 samples that did not pass QC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2A4791B5-EEA4-74B6-D47B-874A2839EED8}"/>
              </a:ext>
            </a:extLst>
          </p:cNvPr>
          <p:cNvSpPr/>
          <p:nvPr/>
        </p:nvSpPr>
        <p:spPr>
          <a:xfrm>
            <a:off x="480161" y="5044794"/>
            <a:ext cx="1713187" cy="557049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/>
              <a:t>1196 cord blood 450K child samples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7A66CF9B-94CC-79B8-D510-64DBA5F03416}"/>
              </a:ext>
            </a:extLst>
          </p:cNvPr>
          <p:cNvSpPr/>
          <p:nvPr/>
        </p:nvSpPr>
        <p:spPr>
          <a:xfrm>
            <a:off x="480161" y="6145754"/>
            <a:ext cx="1713187" cy="557049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/>
              <a:t>385 children from three cohorts</a:t>
            </a: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C93745E5-186E-37DC-E39B-5E0B61599E48}"/>
              </a:ext>
            </a:extLst>
          </p:cNvPr>
          <p:cNvSpPr/>
          <p:nvPr/>
        </p:nvSpPr>
        <p:spPr>
          <a:xfrm>
            <a:off x="3601732" y="5649115"/>
            <a:ext cx="1965936" cy="557049"/>
          </a:xfrm>
          <a:prstGeom prst="rect">
            <a:avLst/>
          </a:prstGeom>
          <a:solidFill>
            <a:schemeClr val="bg2"/>
          </a:solidFill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/>
              <a:t>Remove 811 samples without opioid data</a:t>
            </a:r>
          </a:p>
        </p:txBody>
      </p: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E6CC40F9-9691-65DB-B0BC-1B1D73A041B0}"/>
              </a:ext>
            </a:extLst>
          </p:cNvPr>
          <p:cNvCxnSpPr>
            <a:cxnSpLocks/>
          </p:cNvCxnSpPr>
          <p:nvPr/>
        </p:nvCxnSpPr>
        <p:spPr>
          <a:xfrm>
            <a:off x="1546960" y="5906374"/>
            <a:ext cx="184456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111D5B73-0BF3-7E05-55C6-B29082E53F7B}"/>
              </a:ext>
            </a:extLst>
          </p:cNvPr>
          <p:cNvCxnSpPr>
            <a:cxnSpLocks/>
          </p:cNvCxnSpPr>
          <p:nvPr/>
        </p:nvCxnSpPr>
        <p:spPr>
          <a:xfrm>
            <a:off x="1318636" y="1275855"/>
            <a:ext cx="0" cy="35515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5A74D7D4-BB6E-7FBC-FB6B-793C44B0B2FE}"/>
              </a:ext>
            </a:extLst>
          </p:cNvPr>
          <p:cNvCxnSpPr>
            <a:cxnSpLocks/>
          </p:cNvCxnSpPr>
          <p:nvPr/>
        </p:nvCxnSpPr>
        <p:spPr>
          <a:xfrm>
            <a:off x="1318636" y="2389704"/>
            <a:ext cx="0" cy="35515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4931DAC3-067F-9878-88E2-DCD4C9889B3A}"/>
              </a:ext>
            </a:extLst>
          </p:cNvPr>
          <p:cNvCxnSpPr>
            <a:cxnSpLocks/>
          </p:cNvCxnSpPr>
          <p:nvPr/>
        </p:nvCxnSpPr>
        <p:spPr>
          <a:xfrm>
            <a:off x="1318636" y="3511370"/>
            <a:ext cx="0" cy="35515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8454DC9A-1530-94E0-7754-3B51EC042303}"/>
              </a:ext>
            </a:extLst>
          </p:cNvPr>
          <p:cNvCxnSpPr>
            <a:cxnSpLocks/>
          </p:cNvCxnSpPr>
          <p:nvPr/>
        </p:nvCxnSpPr>
        <p:spPr>
          <a:xfrm>
            <a:off x="1318636" y="4604557"/>
            <a:ext cx="0" cy="35515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9B7EE791-8511-1DEB-8CFE-511DBD1E8D67}"/>
              </a:ext>
            </a:extLst>
          </p:cNvPr>
          <p:cNvCxnSpPr>
            <a:cxnSpLocks/>
          </p:cNvCxnSpPr>
          <p:nvPr/>
        </p:nvCxnSpPr>
        <p:spPr>
          <a:xfrm>
            <a:off x="1318636" y="5728799"/>
            <a:ext cx="0" cy="35515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Rectangle 32">
            <a:extLst>
              <a:ext uri="{FF2B5EF4-FFF2-40B4-BE49-F238E27FC236}">
                <a16:creationId xmlns:a16="http://schemas.microsoft.com/office/drawing/2014/main" id="{9CDE8EEA-2950-78E0-7910-5F71F6AB7FE9}"/>
              </a:ext>
            </a:extLst>
          </p:cNvPr>
          <p:cNvSpPr/>
          <p:nvPr/>
        </p:nvSpPr>
        <p:spPr>
          <a:xfrm>
            <a:off x="6680013" y="559218"/>
            <a:ext cx="1713187" cy="557049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/>
              <a:t>9035 participants with high quality Illumina DNA methylation data</a:t>
            </a:r>
          </a:p>
        </p:txBody>
      </p: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12DAB65F-9A63-8E44-7764-8012B13233BE}"/>
              </a:ext>
            </a:extLst>
          </p:cNvPr>
          <p:cNvCxnSpPr>
            <a:cxnSpLocks/>
          </p:cNvCxnSpPr>
          <p:nvPr/>
        </p:nvCxnSpPr>
        <p:spPr>
          <a:xfrm>
            <a:off x="7713859" y="1312586"/>
            <a:ext cx="184456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Rectangle 34">
            <a:extLst>
              <a:ext uri="{FF2B5EF4-FFF2-40B4-BE49-F238E27FC236}">
                <a16:creationId xmlns:a16="http://schemas.microsoft.com/office/drawing/2014/main" id="{98C354C8-44C4-80FD-5C9C-F2F95B829B61}"/>
              </a:ext>
            </a:extLst>
          </p:cNvPr>
          <p:cNvSpPr/>
          <p:nvPr/>
        </p:nvSpPr>
        <p:spPr>
          <a:xfrm>
            <a:off x="6680010" y="1508536"/>
            <a:ext cx="1713187" cy="557049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/>
              <a:t>8028 child samples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6195ED9F-81BC-6974-140A-C91D4FD6E611}"/>
              </a:ext>
            </a:extLst>
          </p:cNvPr>
          <p:cNvSpPr/>
          <p:nvPr/>
        </p:nvSpPr>
        <p:spPr>
          <a:xfrm>
            <a:off x="9801577" y="1062496"/>
            <a:ext cx="1969254" cy="557049"/>
          </a:xfrm>
          <a:prstGeom prst="rect">
            <a:avLst/>
          </a:prstGeom>
          <a:solidFill>
            <a:schemeClr val="bg2"/>
          </a:solidFill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/>
              <a:t>Remove 1007 maternal samples</a:t>
            </a:r>
          </a:p>
        </p:txBody>
      </p: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3CCBDCFA-DC48-C132-10E1-B4827E8DFB48}"/>
              </a:ext>
            </a:extLst>
          </p:cNvPr>
          <p:cNvCxnSpPr>
            <a:cxnSpLocks/>
          </p:cNvCxnSpPr>
          <p:nvPr/>
        </p:nvCxnSpPr>
        <p:spPr>
          <a:xfrm>
            <a:off x="7713859" y="2282682"/>
            <a:ext cx="184456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Rectangle 37">
            <a:extLst>
              <a:ext uri="{FF2B5EF4-FFF2-40B4-BE49-F238E27FC236}">
                <a16:creationId xmlns:a16="http://schemas.microsoft.com/office/drawing/2014/main" id="{D9EDB3DD-D854-79E7-FA39-1765C41F6E07}"/>
              </a:ext>
            </a:extLst>
          </p:cNvPr>
          <p:cNvSpPr/>
          <p:nvPr/>
        </p:nvSpPr>
        <p:spPr>
          <a:xfrm>
            <a:off x="9801578" y="2012549"/>
            <a:ext cx="1969254" cy="557049"/>
          </a:xfrm>
          <a:prstGeom prst="rect">
            <a:avLst/>
          </a:prstGeom>
          <a:solidFill>
            <a:schemeClr val="bg2"/>
          </a:solidFill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/>
              <a:t>Remove 4229 </a:t>
            </a:r>
            <a:r>
              <a:rPr lang="en-US" sz="1200" dirty="0"/>
              <a:t>samples that do </a:t>
            </a:r>
            <a:r>
              <a:rPr lang="en-US" sz="1200" i="1" dirty="0"/>
              <a:t>not</a:t>
            </a:r>
            <a:r>
              <a:rPr lang="en-US" sz="1200" dirty="0"/>
              <a:t> contain Knight clock data</a:t>
            </a: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718A9C2D-E8CA-F4D4-B94F-BD5B53238845}"/>
              </a:ext>
            </a:extLst>
          </p:cNvPr>
          <p:cNvSpPr/>
          <p:nvPr/>
        </p:nvSpPr>
        <p:spPr>
          <a:xfrm>
            <a:off x="6680010" y="2457854"/>
            <a:ext cx="1713187" cy="557049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/>
              <a:t>3799 child Knight clock samples</a:t>
            </a:r>
          </a:p>
        </p:txBody>
      </p: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D53A5B04-74E7-DAF4-7A4A-445CDE1C9A5D}"/>
              </a:ext>
            </a:extLst>
          </p:cNvPr>
          <p:cNvCxnSpPr>
            <a:cxnSpLocks/>
          </p:cNvCxnSpPr>
          <p:nvPr/>
        </p:nvCxnSpPr>
        <p:spPr>
          <a:xfrm>
            <a:off x="7713859" y="3223179"/>
            <a:ext cx="184456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Rectangle 40">
            <a:extLst>
              <a:ext uri="{FF2B5EF4-FFF2-40B4-BE49-F238E27FC236}">
                <a16:creationId xmlns:a16="http://schemas.microsoft.com/office/drawing/2014/main" id="{FEAC03DF-A803-129A-4897-65F5C04B2CB6}"/>
              </a:ext>
            </a:extLst>
          </p:cNvPr>
          <p:cNvSpPr/>
          <p:nvPr/>
        </p:nvSpPr>
        <p:spPr>
          <a:xfrm>
            <a:off x="9801578" y="2962602"/>
            <a:ext cx="1969254" cy="557049"/>
          </a:xfrm>
          <a:prstGeom prst="rect">
            <a:avLst/>
          </a:prstGeom>
          <a:solidFill>
            <a:schemeClr val="bg2"/>
          </a:solidFill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/>
              <a:t>Remove 1401 samples from tissues </a:t>
            </a:r>
            <a:r>
              <a:rPr lang="en-US" sz="1200" i="1" dirty="0"/>
              <a:t>other than </a:t>
            </a:r>
            <a:r>
              <a:rPr lang="en-US" sz="1200" dirty="0"/>
              <a:t>cord blood and dried blood spot </a:t>
            </a: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E6DA1080-B9AD-F322-C76F-51400B94C8E1}"/>
              </a:ext>
            </a:extLst>
          </p:cNvPr>
          <p:cNvSpPr/>
          <p:nvPr/>
        </p:nvSpPr>
        <p:spPr>
          <a:xfrm>
            <a:off x="6680010" y="3407172"/>
            <a:ext cx="1713187" cy="557049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/>
              <a:t>2398 child cord blood and blood spot Knight clock samples</a:t>
            </a:r>
          </a:p>
        </p:txBody>
      </p: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2B5C6CF6-EE05-0805-83A4-DC5B72020F63}"/>
              </a:ext>
            </a:extLst>
          </p:cNvPr>
          <p:cNvCxnSpPr>
            <a:cxnSpLocks/>
          </p:cNvCxnSpPr>
          <p:nvPr/>
        </p:nvCxnSpPr>
        <p:spPr>
          <a:xfrm>
            <a:off x="7713859" y="4174981"/>
            <a:ext cx="184456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Rectangle 43">
            <a:extLst>
              <a:ext uri="{FF2B5EF4-FFF2-40B4-BE49-F238E27FC236}">
                <a16:creationId xmlns:a16="http://schemas.microsoft.com/office/drawing/2014/main" id="{CD289392-D950-0E38-C19D-D7B03AB71422}"/>
              </a:ext>
            </a:extLst>
          </p:cNvPr>
          <p:cNvSpPr/>
          <p:nvPr/>
        </p:nvSpPr>
        <p:spPr>
          <a:xfrm>
            <a:off x="9801578" y="3912655"/>
            <a:ext cx="1969253" cy="557049"/>
          </a:xfrm>
          <a:prstGeom prst="rect">
            <a:avLst/>
          </a:prstGeom>
          <a:solidFill>
            <a:schemeClr val="bg2"/>
          </a:solidFill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/>
              <a:t>Remove 9 samples that did not pass QC</a:t>
            </a: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530269C3-2E29-68EE-5771-0F0A980EB284}"/>
              </a:ext>
            </a:extLst>
          </p:cNvPr>
          <p:cNvSpPr/>
          <p:nvPr/>
        </p:nvSpPr>
        <p:spPr>
          <a:xfrm>
            <a:off x="6680010" y="4356490"/>
            <a:ext cx="1713187" cy="557049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/>
              <a:t>2389 child cord blood and blood spot Knight clock samples</a:t>
            </a:r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0863E7BB-B973-96BD-2BEF-66B5C8144752}"/>
              </a:ext>
            </a:extLst>
          </p:cNvPr>
          <p:cNvSpPr/>
          <p:nvPr/>
        </p:nvSpPr>
        <p:spPr>
          <a:xfrm>
            <a:off x="6680010" y="5305808"/>
            <a:ext cx="1713187" cy="557049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/>
              <a:t>2387 child cord blood and blood spot Knight clock samples</a:t>
            </a: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FA134E3C-4741-8437-437D-E28EB0AA2B65}"/>
              </a:ext>
            </a:extLst>
          </p:cNvPr>
          <p:cNvSpPr/>
          <p:nvPr/>
        </p:nvSpPr>
        <p:spPr>
          <a:xfrm>
            <a:off x="9801578" y="4862708"/>
            <a:ext cx="1969253" cy="557049"/>
          </a:xfrm>
          <a:prstGeom prst="rect">
            <a:avLst/>
          </a:prstGeom>
          <a:solidFill>
            <a:schemeClr val="bg2"/>
          </a:solidFill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/>
              <a:t>Remove 2 duplicate samples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80B08149-BE53-5FBD-9187-D3209A457739}"/>
              </a:ext>
            </a:extLst>
          </p:cNvPr>
          <p:cNvCxnSpPr>
            <a:cxnSpLocks/>
          </p:cNvCxnSpPr>
          <p:nvPr/>
        </p:nvCxnSpPr>
        <p:spPr>
          <a:xfrm>
            <a:off x="7713859" y="5115089"/>
            <a:ext cx="184456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9" name="Rectangle 48">
            <a:extLst>
              <a:ext uri="{FF2B5EF4-FFF2-40B4-BE49-F238E27FC236}">
                <a16:creationId xmlns:a16="http://schemas.microsoft.com/office/drawing/2014/main" id="{19B7C915-CBB0-8E27-DE5B-CBF6C27662BB}"/>
              </a:ext>
            </a:extLst>
          </p:cNvPr>
          <p:cNvSpPr/>
          <p:nvPr/>
        </p:nvSpPr>
        <p:spPr>
          <a:xfrm>
            <a:off x="6680010" y="6255125"/>
            <a:ext cx="1713187" cy="557049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/>
              <a:t>716 participants from eight cohorts</a:t>
            </a:r>
          </a:p>
        </p:txBody>
      </p: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6F36B3E7-F028-346B-130C-784962FCDB2C}"/>
              </a:ext>
            </a:extLst>
          </p:cNvPr>
          <p:cNvCxnSpPr>
            <a:cxnSpLocks/>
          </p:cNvCxnSpPr>
          <p:nvPr/>
        </p:nvCxnSpPr>
        <p:spPr>
          <a:xfrm>
            <a:off x="7713859" y="6091286"/>
            <a:ext cx="184456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Rectangle 50">
            <a:extLst>
              <a:ext uri="{FF2B5EF4-FFF2-40B4-BE49-F238E27FC236}">
                <a16:creationId xmlns:a16="http://schemas.microsoft.com/office/drawing/2014/main" id="{3889020B-D081-F197-C121-1A838155DBCB}"/>
              </a:ext>
            </a:extLst>
          </p:cNvPr>
          <p:cNvSpPr/>
          <p:nvPr/>
        </p:nvSpPr>
        <p:spPr>
          <a:xfrm>
            <a:off x="9801578" y="5812761"/>
            <a:ext cx="1969253" cy="557049"/>
          </a:xfrm>
          <a:prstGeom prst="rect">
            <a:avLst/>
          </a:prstGeom>
          <a:solidFill>
            <a:schemeClr val="bg2"/>
          </a:solidFill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/>
              <a:t>Remove 1671 samples without opioid data</a:t>
            </a:r>
          </a:p>
        </p:txBody>
      </p: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6CC2AAA7-FE35-1E27-BA4D-E49F77728EDA}"/>
              </a:ext>
            </a:extLst>
          </p:cNvPr>
          <p:cNvCxnSpPr>
            <a:cxnSpLocks/>
          </p:cNvCxnSpPr>
          <p:nvPr/>
        </p:nvCxnSpPr>
        <p:spPr>
          <a:xfrm>
            <a:off x="7529534" y="1177111"/>
            <a:ext cx="0" cy="27095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80438F23-7476-4F5F-C3F7-0278941414DB}"/>
              </a:ext>
            </a:extLst>
          </p:cNvPr>
          <p:cNvCxnSpPr>
            <a:cxnSpLocks/>
          </p:cNvCxnSpPr>
          <p:nvPr/>
        </p:nvCxnSpPr>
        <p:spPr>
          <a:xfrm>
            <a:off x="7529534" y="2132851"/>
            <a:ext cx="0" cy="27095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4" name="Straight Arrow Connector 53">
            <a:extLst>
              <a:ext uri="{FF2B5EF4-FFF2-40B4-BE49-F238E27FC236}">
                <a16:creationId xmlns:a16="http://schemas.microsoft.com/office/drawing/2014/main" id="{9F2F06E0-A6C2-E036-46A5-9BF243E00E79}"/>
              </a:ext>
            </a:extLst>
          </p:cNvPr>
          <p:cNvCxnSpPr>
            <a:cxnSpLocks/>
          </p:cNvCxnSpPr>
          <p:nvPr/>
        </p:nvCxnSpPr>
        <p:spPr>
          <a:xfrm>
            <a:off x="7529534" y="3088591"/>
            <a:ext cx="0" cy="27095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5" name="Straight Arrow Connector 54">
            <a:extLst>
              <a:ext uri="{FF2B5EF4-FFF2-40B4-BE49-F238E27FC236}">
                <a16:creationId xmlns:a16="http://schemas.microsoft.com/office/drawing/2014/main" id="{24BC7348-E936-60A9-A841-B75235C5F5CE}"/>
              </a:ext>
            </a:extLst>
          </p:cNvPr>
          <p:cNvCxnSpPr>
            <a:cxnSpLocks/>
          </p:cNvCxnSpPr>
          <p:nvPr/>
        </p:nvCxnSpPr>
        <p:spPr>
          <a:xfrm>
            <a:off x="7529534" y="4044331"/>
            <a:ext cx="0" cy="27095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741EC968-FB59-034B-E44F-8CB5D52C17AB}"/>
              </a:ext>
            </a:extLst>
          </p:cNvPr>
          <p:cNvCxnSpPr>
            <a:cxnSpLocks/>
          </p:cNvCxnSpPr>
          <p:nvPr/>
        </p:nvCxnSpPr>
        <p:spPr>
          <a:xfrm>
            <a:off x="7529534" y="5000071"/>
            <a:ext cx="0" cy="27095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EFD7B23A-DC84-E85D-2393-1B13ED6AF5EB}"/>
              </a:ext>
            </a:extLst>
          </p:cNvPr>
          <p:cNvCxnSpPr>
            <a:cxnSpLocks/>
          </p:cNvCxnSpPr>
          <p:nvPr/>
        </p:nvCxnSpPr>
        <p:spPr>
          <a:xfrm>
            <a:off x="7529534" y="5955811"/>
            <a:ext cx="0" cy="27095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C965821D-C27C-31D1-1F49-F23E11718716}"/>
              </a:ext>
            </a:extLst>
          </p:cNvPr>
          <p:cNvCxnSpPr/>
          <p:nvPr/>
        </p:nvCxnSpPr>
        <p:spPr>
          <a:xfrm>
            <a:off x="6099830" y="900025"/>
            <a:ext cx="0" cy="557784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1" name="TextBox 60">
            <a:extLst>
              <a:ext uri="{FF2B5EF4-FFF2-40B4-BE49-F238E27FC236}">
                <a16:creationId xmlns:a16="http://schemas.microsoft.com/office/drawing/2014/main" id="{CC522295-DC28-629C-1C01-DC9784BC553C}"/>
              </a:ext>
            </a:extLst>
          </p:cNvPr>
          <p:cNvSpPr txBox="1"/>
          <p:nvPr/>
        </p:nvSpPr>
        <p:spPr>
          <a:xfrm>
            <a:off x="1371" y="10590"/>
            <a:ext cx="1198905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dirty="0"/>
              <a:t>Supplementary Figure 1.</a:t>
            </a:r>
            <a:r>
              <a:rPr lang="en-US" sz="1200" dirty="0">
                <a:effectLst/>
              </a:rPr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134618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221</Words>
  <Application>Microsoft Macintosh PowerPoint</Application>
  <PresentationFormat>Widescreen</PresentationFormat>
  <Paragraphs>2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cp:lastModifiedBy>Rose Schrott</cp:lastModifiedBy>
  <cp:revision>10</cp:revision>
  <dcterms:modified xsi:type="dcterms:W3CDTF">2023-08-14T18:18:06Z</dcterms:modified>
</cp:coreProperties>
</file>